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A488322-F2BA-4B5B-9748-0D474271808F}" styleName="中間スタイル 3 - アクセント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70"/>
  </p:normalViewPr>
  <p:slideViewPr>
    <p:cSldViewPr snapToGrid="0" snapToObjects="1">
      <p:cViewPr varScale="1">
        <p:scale>
          <a:sx n="74" d="100"/>
          <a:sy n="74" d="100"/>
        </p:scale>
        <p:origin x="1266" y="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677C3-0448-4149-8B7C-F7DF0C1B1447}" type="datetimeFigureOut">
              <a:rPr kumimoji="1" lang="ja-JP" altLang="en-US" smtClean="0"/>
              <a:t>2020/10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62432-A3FB-D74A-8748-48F5E49F39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56151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677C3-0448-4149-8B7C-F7DF0C1B1447}" type="datetimeFigureOut">
              <a:rPr kumimoji="1" lang="ja-JP" altLang="en-US" smtClean="0"/>
              <a:t>2020/10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62432-A3FB-D74A-8748-48F5E49F39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2425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677C3-0448-4149-8B7C-F7DF0C1B1447}" type="datetimeFigureOut">
              <a:rPr kumimoji="1" lang="ja-JP" altLang="en-US" smtClean="0"/>
              <a:t>2020/10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62432-A3FB-D74A-8748-48F5E49F39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72619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677C3-0448-4149-8B7C-F7DF0C1B1447}" type="datetimeFigureOut">
              <a:rPr kumimoji="1" lang="ja-JP" altLang="en-US" smtClean="0"/>
              <a:t>2020/10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62432-A3FB-D74A-8748-48F5E49F39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41694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677C3-0448-4149-8B7C-F7DF0C1B1447}" type="datetimeFigureOut">
              <a:rPr kumimoji="1" lang="ja-JP" altLang="en-US" smtClean="0"/>
              <a:t>2020/10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62432-A3FB-D74A-8748-48F5E49F39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76416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677C3-0448-4149-8B7C-F7DF0C1B1447}" type="datetimeFigureOut">
              <a:rPr kumimoji="1" lang="ja-JP" altLang="en-US" smtClean="0"/>
              <a:t>2020/10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62432-A3FB-D74A-8748-48F5E49F39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95643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677C3-0448-4149-8B7C-F7DF0C1B1447}" type="datetimeFigureOut">
              <a:rPr kumimoji="1" lang="ja-JP" altLang="en-US" smtClean="0"/>
              <a:t>2020/10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62432-A3FB-D74A-8748-48F5E49F39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41384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677C3-0448-4149-8B7C-F7DF0C1B1447}" type="datetimeFigureOut">
              <a:rPr kumimoji="1" lang="ja-JP" altLang="en-US" smtClean="0"/>
              <a:t>2020/10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62432-A3FB-D74A-8748-48F5E49F39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85405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677C3-0448-4149-8B7C-F7DF0C1B1447}" type="datetimeFigureOut">
              <a:rPr kumimoji="1" lang="ja-JP" altLang="en-US" smtClean="0"/>
              <a:t>2020/10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62432-A3FB-D74A-8748-48F5E49F39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79844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677C3-0448-4149-8B7C-F7DF0C1B1447}" type="datetimeFigureOut">
              <a:rPr kumimoji="1" lang="ja-JP" altLang="en-US" smtClean="0"/>
              <a:t>2020/10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62432-A3FB-D74A-8748-48F5E49F39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24639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677C3-0448-4149-8B7C-F7DF0C1B1447}" type="datetimeFigureOut">
              <a:rPr kumimoji="1" lang="ja-JP" altLang="en-US" smtClean="0"/>
              <a:t>2020/10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462432-A3FB-D74A-8748-48F5E49F39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4700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1677C3-0448-4149-8B7C-F7DF0C1B1447}" type="datetimeFigureOut">
              <a:rPr kumimoji="1" lang="ja-JP" altLang="en-US" smtClean="0"/>
              <a:t>2020/10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462432-A3FB-D74A-8748-48F5E49F39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4473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テキスト ボックス 100"/>
          <p:cNvSpPr txBox="1"/>
          <p:nvPr/>
        </p:nvSpPr>
        <p:spPr>
          <a:xfrm>
            <a:off x="0" y="19617"/>
            <a:ext cx="44117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Additional </a:t>
            </a:r>
            <a:r>
              <a:rPr lang="en-US" altLang="ja-JP" sz="16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D</a:t>
            </a:r>
            <a:r>
              <a:rPr kumimoji="1" lang="en-US" altLang="ja-JP" sz="16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ata </a:t>
            </a:r>
            <a:r>
              <a:rPr kumimoji="1" lang="en-US" altLang="ja-JP" sz="1600" dirty="0" err="1" smtClean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S2</a:t>
            </a:r>
            <a:r>
              <a:rPr kumimoji="1" lang="en-US" altLang="ja-JP" sz="16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. </a:t>
            </a:r>
            <a:r>
              <a:rPr lang="en-US" altLang="ja-JP" sz="1600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Primer set used for sequencing</a:t>
            </a:r>
            <a:endParaRPr kumimoji="1" lang="ja-JP" altLang="en-US" sz="1600" dirty="0">
              <a:latin typeface="Times New Roman" panose="02020603050405020304" pitchFamily="18" charset="0"/>
              <a:ea typeface="Arial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表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41248028"/>
              </p:ext>
            </p:extLst>
          </p:nvPr>
        </p:nvGraphicFramePr>
        <p:xfrm>
          <a:off x="371061" y="503578"/>
          <a:ext cx="8613914" cy="6127483"/>
        </p:xfrm>
        <a:graphic>
          <a:graphicData uri="http://schemas.openxmlformats.org/drawingml/2006/table">
            <a:tbl>
              <a:tblPr>
                <a:tableStyleId>{2A488322-F2BA-4B5B-9748-0D474271808F}</a:tableStyleId>
              </a:tblPr>
              <a:tblGrid>
                <a:gridCol w="806969">
                  <a:extLst>
                    <a:ext uri="{9D8B030D-6E8A-4147-A177-3AD203B41FA5}">
                      <a16:colId xmlns:a16="http://schemas.microsoft.com/office/drawing/2014/main" xmlns="" val="3393667412"/>
                    </a:ext>
                  </a:extLst>
                </a:gridCol>
                <a:gridCol w="412866">
                  <a:extLst>
                    <a:ext uri="{9D8B030D-6E8A-4147-A177-3AD203B41FA5}">
                      <a16:colId xmlns:a16="http://schemas.microsoft.com/office/drawing/2014/main" xmlns="" val="3760350954"/>
                    </a:ext>
                  </a:extLst>
                </a:gridCol>
                <a:gridCol w="600532">
                  <a:extLst>
                    <a:ext uri="{9D8B030D-6E8A-4147-A177-3AD203B41FA5}">
                      <a16:colId xmlns:a16="http://schemas.microsoft.com/office/drawing/2014/main" xmlns="" val="1059491210"/>
                    </a:ext>
                  </a:extLst>
                </a:gridCol>
                <a:gridCol w="2685374">
                  <a:extLst>
                    <a:ext uri="{9D8B030D-6E8A-4147-A177-3AD203B41FA5}">
                      <a16:colId xmlns:a16="http://schemas.microsoft.com/office/drawing/2014/main" xmlns="" val="958191592"/>
                    </a:ext>
                  </a:extLst>
                </a:gridCol>
                <a:gridCol w="781878">
                  <a:extLst>
                    <a:ext uri="{9D8B030D-6E8A-4147-A177-3AD203B41FA5}">
                      <a16:colId xmlns:a16="http://schemas.microsoft.com/office/drawing/2014/main" xmlns="" val="1449567947"/>
                    </a:ext>
                  </a:extLst>
                </a:gridCol>
                <a:gridCol w="410818">
                  <a:extLst>
                    <a:ext uri="{9D8B030D-6E8A-4147-A177-3AD203B41FA5}">
                      <a16:colId xmlns:a16="http://schemas.microsoft.com/office/drawing/2014/main" xmlns="" val="314278296"/>
                    </a:ext>
                  </a:extLst>
                </a:gridCol>
                <a:gridCol w="543339">
                  <a:extLst>
                    <a:ext uri="{9D8B030D-6E8A-4147-A177-3AD203B41FA5}">
                      <a16:colId xmlns:a16="http://schemas.microsoft.com/office/drawing/2014/main" xmlns="" val="4204748038"/>
                    </a:ext>
                  </a:extLst>
                </a:gridCol>
                <a:gridCol w="2372138">
                  <a:extLst>
                    <a:ext uri="{9D8B030D-6E8A-4147-A177-3AD203B41FA5}">
                      <a16:colId xmlns:a16="http://schemas.microsoft.com/office/drawing/2014/main" xmlns="" val="931048765"/>
                    </a:ext>
                  </a:extLst>
                </a:gridCol>
              </a:tblGrid>
              <a:tr h="285017"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b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ymbol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s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b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ymbol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s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146165689"/>
                  </a:ext>
                </a:extLst>
              </a:tr>
              <a:tr h="26737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H</a:t>
                      </a:r>
                      <a:endParaRPr lang="en-US" sz="110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ja-JP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TCCGAGAAGACTTGGACTGG-3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altLang="ja-JP" sz="110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L</a:t>
                      </a:r>
                      <a:r>
                        <a:rPr lang="en-US" sz="110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10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100" u="none" strike="noStrike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TGCAGTGGTGTGATCTCG</a:t>
                      </a:r>
                      <a:r>
                        <a:rPr lang="en-US" altLang="ja-JP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100" u="none" strike="noStrike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xmlns="" val="721885899"/>
                  </a:ext>
                </a:extLst>
              </a:tr>
              <a:tr h="267373"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ATTGTTGGCCTGGTAGGT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GGTCAAGGTGGGAGGATT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extLst>
                  <a:ext uri="{0D108BD9-81ED-4DB2-BD59-A6C34878D82A}">
                    <a16:rowId xmlns:a16="http://schemas.microsoft.com/office/drawing/2014/main" xmlns="" val="1079845220"/>
                  </a:ext>
                </a:extLst>
              </a:tr>
              <a:tr h="26737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HR2</a:t>
                      </a:r>
                      <a:endParaRPr lang="en-US" sz="110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ja-JP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CGAACCTGTGTGTTCTTT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altLang="ja-JP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GTGCAGGGATATACGACA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extLst>
                  <a:ext uri="{0D108BD9-81ED-4DB2-BD59-A6C34878D82A}">
                    <a16:rowId xmlns:a16="http://schemas.microsoft.com/office/drawing/2014/main" xmlns="" val="952006342"/>
                  </a:ext>
                </a:extLst>
              </a:tr>
              <a:tr h="267373"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AGGTTCCAGATCCCAAAG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AGGCCTGTAGATGCGAGA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extLst>
                  <a:ext uri="{0D108BD9-81ED-4DB2-BD59-A6C34878D82A}">
                    <a16:rowId xmlns:a16="http://schemas.microsoft.com/office/drawing/2014/main" xmlns="" val="262691336"/>
                  </a:ext>
                </a:extLst>
              </a:tr>
              <a:tr h="267373"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altLang="ja-JP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TGGCTCCACTCTCTTCAC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XFP2</a:t>
                      </a:r>
                      <a:endParaRPr lang="en-US" sz="110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ja-JP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GTCATGTCATCATTTGGG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extLst>
                  <a:ext uri="{0D108BD9-81ED-4DB2-BD59-A6C34878D82A}">
                    <a16:rowId xmlns:a16="http://schemas.microsoft.com/office/drawing/2014/main" xmlns="" val="2529003248"/>
                  </a:ext>
                </a:extLst>
              </a:tr>
              <a:tr h="267373"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CTTATCTCCCAGTCACCA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CCTGAATAGGAAGCATG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extLst>
                  <a:ext uri="{0D108BD9-81ED-4DB2-BD59-A6C34878D82A}">
                    <a16:rowId xmlns:a16="http://schemas.microsoft.com/office/drawing/2014/main" xmlns="" val="1391720930"/>
                  </a:ext>
                </a:extLst>
              </a:tr>
              <a:tr h="267373"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ja-JP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GGTCTGTGGCTCAGTTCC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altLang="ja-JP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ACTGGGCTTGTGGTTATC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extLst>
                  <a:ext uri="{0D108BD9-81ED-4DB2-BD59-A6C34878D82A}">
                    <a16:rowId xmlns:a16="http://schemas.microsoft.com/office/drawing/2014/main" xmlns="" val="368285285"/>
                  </a:ext>
                </a:extLst>
              </a:tr>
              <a:tr h="267373"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CAGTTCCAGTACCAGCAG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CAAGCTAGAGAAGACAAG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extLst>
                  <a:ext uri="{0D108BD9-81ED-4DB2-BD59-A6C34878D82A}">
                    <a16:rowId xmlns:a16="http://schemas.microsoft.com/office/drawing/2014/main" xmlns="" val="723657908"/>
                  </a:ext>
                </a:extLst>
              </a:tr>
              <a:tr h="267373"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altLang="ja-JP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GGTCTGTGGCTCAGTTCC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ja-JP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CAGGACCTCAAATTGCTC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extLst>
                  <a:ext uri="{0D108BD9-81ED-4DB2-BD59-A6C34878D82A}">
                    <a16:rowId xmlns:a16="http://schemas.microsoft.com/office/drawing/2014/main" xmlns="" val="676199110"/>
                  </a:ext>
                </a:extLst>
              </a:tr>
              <a:tr h="267373"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CCAAAGTGCTGGGATTAC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GAAACTGGAACTTTCAGG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extLst>
                  <a:ext uri="{0D108BD9-81ED-4DB2-BD59-A6C34878D82A}">
                    <a16:rowId xmlns:a16="http://schemas.microsoft.com/office/drawing/2014/main" xmlns="" val="2508768482"/>
                  </a:ext>
                </a:extLst>
              </a:tr>
              <a:tr h="267373"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US" altLang="ja-JP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CTGTGGGCCTGTTAAATA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altLang="ja-JP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CCTTCCAGAAAATTCCC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extLst>
                  <a:ext uri="{0D108BD9-81ED-4DB2-BD59-A6C34878D82A}">
                    <a16:rowId xmlns:a16="http://schemas.microsoft.com/office/drawing/2014/main" xmlns="" val="1675180060"/>
                  </a:ext>
                </a:extLst>
              </a:tr>
              <a:tr h="267373"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TAATGCCTAGCAGGAAGC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ATTCCCAAGACATACTCC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extLst>
                  <a:ext uri="{0D108BD9-81ED-4DB2-BD59-A6C34878D82A}">
                    <a16:rowId xmlns:a16="http://schemas.microsoft.com/office/drawing/2014/main" xmlns="" val="613646121"/>
                  </a:ext>
                </a:extLst>
              </a:tr>
              <a:tr h="267373"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altLang="ja-JP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AAAGTCATTTGCCCAGAA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extLst>
                  <a:ext uri="{0D108BD9-81ED-4DB2-BD59-A6C34878D82A}">
                    <a16:rowId xmlns:a16="http://schemas.microsoft.com/office/drawing/2014/main" xmlns="" val="3777469942"/>
                  </a:ext>
                </a:extLst>
              </a:tr>
              <a:tr h="267373"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GTCCTGATGGAGGGGTAA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extLst>
                  <a:ext uri="{0D108BD9-81ED-4DB2-BD59-A6C34878D82A}">
                    <a16:rowId xmlns:a16="http://schemas.microsoft.com/office/drawing/2014/main" xmlns="" val="2995377300"/>
                  </a:ext>
                </a:extLst>
              </a:tr>
              <a:tr h="267373"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US" altLang="ja-JP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TATTGTCTTGGCCAGCAT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extLst>
                  <a:ext uri="{0D108BD9-81ED-4DB2-BD59-A6C34878D82A}">
                    <a16:rowId xmlns:a16="http://schemas.microsoft.com/office/drawing/2014/main" xmlns="" val="3454684034"/>
                  </a:ext>
                </a:extLst>
              </a:tr>
              <a:tr h="267373"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GCTGGCCAAGACAATAGG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extLst>
                  <a:ext uri="{0D108BD9-81ED-4DB2-BD59-A6C34878D82A}">
                    <a16:rowId xmlns:a16="http://schemas.microsoft.com/office/drawing/2014/main" xmlns="" val="2754761053"/>
                  </a:ext>
                </a:extLst>
              </a:tr>
              <a:tr h="267373"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altLang="ja-JP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GTCAAAAGAGGGAGGAAG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extLst>
                  <a:ext uri="{0D108BD9-81ED-4DB2-BD59-A6C34878D82A}">
                    <a16:rowId xmlns:a16="http://schemas.microsoft.com/office/drawing/2014/main" xmlns="" val="1888854052"/>
                  </a:ext>
                </a:extLst>
              </a:tr>
              <a:tr h="169652"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CCCGGCTAATATTTTGTA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extLst>
                  <a:ext uri="{0D108BD9-81ED-4DB2-BD59-A6C34878D82A}">
                    <a16:rowId xmlns:a16="http://schemas.microsoft.com/office/drawing/2014/main" xmlns="" val="1019189774"/>
                  </a:ext>
                </a:extLst>
              </a:tr>
              <a:tr h="267373"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en-US" altLang="ja-JP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CTCCTTGGTTCATGCTCA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extLst>
                  <a:ext uri="{0D108BD9-81ED-4DB2-BD59-A6C34878D82A}">
                    <a16:rowId xmlns:a16="http://schemas.microsoft.com/office/drawing/2014/main" xmlns="" val="2664775646"/>
                  </a:ext>
                </a:extLst>
              </a:tr>
              <a:tr h="267373"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AGGTTGAGCAGGAGGAAG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extLst>
                  <a:ext uri="{0D108BD9-81ED-4DB2-BD59-A6C34878D82A}">
                    <a16:rowId xmlns:a16="http://schemas.microsoft.com/office/drawing/2014/main" xmlns="" val="2529273742"/>
                  </a:ext>
                </a:extLst>
              </a:tr>
              <a:tr h="267373"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altLang="ja-JP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TAGGGTCAACCCTTCCTC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extLst>
                  <a:ext uri="{0D108BD9-81ED-4DB2-BD59-A6C34878D82A}">
                    <a16:rowId xmlns:a16="http://schemas.microsoft.com/office/drawing/2014/main" xmlns="" val="224537570"/>
                  </a:ext>
                </a:extLst>
              </a:tr>
              <a:tr h="267373"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</a:t>
                      </a:r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TCTGCATCCCAACAGTCT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′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865" marR="4865" marT="4865" marB="0" anchor="ctr"/>
                </a:tc>
                <a:extLst>
                  <a:ext uri="{0D108BD9-81ED-4DB2-BD59-A6C34878D82A}">
                    <a16:rowId xmlns:a16="http://schemas.microsoft.com/office/drawing/2014/main" xmlns="" val="248761987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00553917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29</TotalTime>
  <Words>204</Words>
  <Application>Microsoft Office PowerPoint</Application>
  <PresentationFormat>On-screen Show (4:3)</PresentationFormat>
  <Paragraphs>9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ＭＳ Ｐゴシック</vt:lpstr>
      <vt:lpstr>游ゴシック</vt:lpstr>
      <vt:lpstr>Arial</vt:lpstr>
      <vt:lpstr>Calibri</vt:lpstr>
      <vt:lpstr>Calibri Light</vt:lpstr>
      <vt:lpstr>Times New Roman</vt:lpstr>
      <vt:lpstr>ホワイト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水野健太郎</dc:creator>
  <cp:lastModifiedBy>Janani G.</cp:lastModifiedBy>
  <cp:revision>15</cp:revision>
  <cp:lastPrinted>2020-06-08T06:54:30Z</cp:lastPrinted>
  <dcterms:created xsi:type="dcterms:W3CDTF">2016-05-04T21:35:16Z</dcterms:created>
  <dcterms:modified xsi:type="dcterms:W3CDTF">2020-10-20T05:20:41Z</dcterms:modified>
</cp:coreProperties>
</file>